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2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95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48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472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213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445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077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180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349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723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68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245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E6863-5203-4F0E-B692-D970A83FEFBE}" type="datetimeFigureOut">
              <a:rPr lang="en-US" smtClean="0"/>
              <a:t>9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EE9C4-5D47-4239-B6DC-0D40B37A0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122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74" t="41168"/>
          <a:stretch/>
        </p:blipFill>
        <p:spPr>
          <a:xfrm>
            <a:off x="4319445" y="515703"/>
            <a:ext cx="3359979" cy="12834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7" t="41378"/>
          <a:stretch/>
        </p:blipFill>
        <p:spPr>
          <a:xfrm>
            <a:off x="4323045" y="3525700"/>
            <a:ext cx="3364982" cy="12788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67" t="41965"/>
          <a:stretch/>
        </p:blipFill>
        <p:spPr>
          <a:xfrm>
            <a:off x="4315575" y="5016321"/>
            <a:ext cx="3356379" cy="12660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3" t="41259"/>
          <a:stretch/>
        </p:blipFill>
        <p:spPr>
          <a:xfrm>
            <a:off x="4329919" y="2029394"/>
            <a:ext cx="3358108" cy="12814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21" t="12133"/>
          <a:stretch/>
        </p:blipFill>
        <p:spPr>
          <a:xfrm>
            <a:off x="909874" y="803950"/>
            <a:ext cx="2762924" cy="6168807"/>
          </a:xfrm>
          <a:prstGeom prst="rect">
            <a:avLst/>
          </a:prstGeom>
        </p:spPr>
      </p:pic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1091723"/>
              </p:ext>
            </p:extLst>
          </p:nvPr>
        </p:nvGraphicFramePr>
        <p:xfrm>
          <a:off x="919018" y="465622"/>
          <a:ext cx="2758327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82055"/>
                <a:gridCol w="539496"/>
                <a:gridCol w="548640"/>
                <a:gridCol w="557784"/>
                <a:gridCol w="530352"/>
              </a:tblGrid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Control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Basal-Like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Luminal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L="0" marR="0" marT="0" marB="0"/>
                </a:tc>
              </a:tr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CF10A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HCC1806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DA-231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CF7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T47D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cxnSp>
        <p:nvCxnSpPr>
          <p:cNvPr id="10" name="Straight Connector 9"/>
          <p:cNvCxnSpPr/>
          <p:nvPr/>
        </p:nvCxnSpPr>
        <p:spPr>
          <a:xfrm flipV="1">
            <a:off x="3808016" y="513429"/>
            <a:ext cx="507559" cy="7341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810232" y="1314780"/>
            <a:ext cx="505343" cy="4843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3744236" y="1247570"/>
            <a:ext cx="60377" cy="68983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3744236" y="1316553"/>
            <a:ext cx="60377" cy="187571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3802643" y="1310985"/>
            <a:ext cx="512932" cy="7184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07482" y="1498372"/>
            <a:ext cx="508093" cy="17970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3749779" y="3226462"/>
            <a:ext cx="60377" cy="68983"/>
          </a:xfrm>
          <a:prstGeom prst="rect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>
            <a:off x="3807482" y="3221154"/>
            <a:ext cx="508093" cy="3045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3814108" y="3294041"/>
            <a:ext cx="506896" cy="1507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3744236" y="4922535"/>
            <a:ext cx="60377" cy="187571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" name="Straight Connector 19"/>
          <p:cNvCxnSpPr/>
          <p:nvPr/>
        </p:nvCxnSpPr>
        <p:spPr>
          <a:xfrm>
            <a:off x="3803405" y="4920746"/>
            <a:ext cx="512170" cy="955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806463" y="5107295"/>
            <a:ext cx="501544" cy="11743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0790161"/>
              </p:ext>
            </p:extLst>
          </p:nvPr>
        </p:nvGraphicFramePr>
        <p:xfrm>
          <a:off x="4308007" y="145772"/>
          <a:ext cx="3363946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09851"/>
                <a:gridCol w="657948"/>
                <a:gridCol w="669100"/>
                <a:gridCol w="680251"/>
                <a:gridCol w="646796"/>
              </a:tblGrid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Control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Basal-Like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Luminal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L="0" marR="0" marT="0" marB="0"/>
                </a:tc>
              </a:tr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CF10A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HCC1806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DA-231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MCF7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+mn-lt"/>
                        </a:rPr>
                        <a:t>T47D</a:t>
                      </a:r>
                      <a:endParaRPr lang="en-US" sz="1000" dirty="0">
                        <a:latin typeface="+mn-lt"/>
                      </a:endParaRPr>
                    </a:p>
                  </a:txBody>
                  <a:tcPr marL="0" marR="0" marT="0" marB="0"/>
                </a:tc>
              </a:tr>
            </a:tbl>
          </a:graphicData>
        </a:graphic>
      </p:graphicFrame>
      <p:sp>
        <p:nvSpPr>
          <p:cNvPr id="23" name="Rectangle 22"/>
          <p:cNvSpPr/>
          <p:nvPr/>
        </p:nvSpPr>
        <p:spPr>
          <a:xfrm>
            <a:off x="643386" y="4134880"/>
            <a:ext cx="183193" cy="705026"/>
          </a:xfrm>
          <a:prstGeom prst="rect">
            <a:avLst/>
          </a:prstGeom>
          <a:gradFill flip="none" rotWithShape="1">
            <a:gsLst>
              <a:gs pos="0">
                <a:srgbClr val="FF0404"/>
              </a:gs>
              <a:gs pos="50000">
                <a:schemeClr val="bg1"/>
              </a:gs>
              <a:gs pos="100000">
                <a:srgbClr val="00FF70"/>
              </a:gs>
            </a:gsLst>
            <a:lin ang="5400000" scaled="1"/>
            <a:tileRect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" name="Straight Connector 23"/>
          <p:cNvCxnSpPr>
            <a:endCxn id="23" idx="0"/>
          </p:cNvCxnSpPr>
          <p:nvPr/>
        </p:nvCxnSpPr>
        <p:spPr>
          <a:xfrm>
            <a:off x="454998" y="4134879"/>
            <a:ext cx="27998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 flipV="1">
            <a:off x="461954" y="4839448"/>
            <a:ext cx="363690" cy="59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0053" y="3926086"/>
            <a:ext cx="709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1.5</a:t>
            </a:r>
            <a:endParaRPr lang="en-US" sz="1800" dirty="0"/>
          </a:p>
        </p:txBody>
      </p:sp>
      <p:sp>
        <p:nvSpPr>
          <p:cNvPr id="27" name="TextBox 26"/>
          <p:cNvSpPr txBox="1"/>
          <p:nvPr/>
        </p:nvSpPr>
        <p:spPr>
          <a:xfrm>
            <a:off x="-42451" y="4628701"/>
            <a:ext cx="7704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 smtClean="0"/>
              <a:t>-1.5</a:t>
            </a:r>
            <a:endParaRPr lang="en-US" sz="1800" dirty="0"/>
          </a:p>
        </p:txBody>
      </p:sp>
      <p:sp>
        <p:nvSpPr>
          <p:cNvPr id="28" name="TextBox 27"/>
          <p:cNvSpPr txBox="1"/>
          <p:nvPr/>
        </p:nvSpPr>
        <p:spPr>
          <a:xfrm>
            <a:off x="486242" y="511167"/>
            <a:ext cx="12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4334056" y="511167"/>
            <a:ext cx="12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4337947" y="2017303"/>
            <a:ext cx="12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334056" y="3498094"/>
            <a:ext cx="12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321586" y="4968533"/>
            <a:ext cx="12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5960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4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Ankney</dc:creator>
  <cp:lastModifiedBy>John Ankney</cp:lastModifiedBy>
  <cp:revision>1</cp:revision>
  <dcterms:created xsi:type="dcterms:W3CDTF">2018-09-11T18:47:36Z</dcterms:created>
  <dcterms:modified xsi:type="dcterms:W3CDTF">2018-09-11T18:49:32Z</dcterms:modified>
</cp:coreProperties>
</file>